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87" r:id="rId3"/>
    <p:sldId id="299" r:id="rId4"/>
    <p:sldId id="300" r:id="rId5"/>
    <p:sldId id="292" r:id="rId6"/>
    <p:sldId id="293" r:id="rId7"/>
    <p:sldId id="264" r:id="rId8"/>
    <p:sldId id="288" r:id="rId9"/>
    <p:sldId id="298" r:id="rId10"/>
    <p:sldId id="269" r:id="rId11"/>
    <p:sldId id="270" r:id="rId12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5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688" y="56"/>
      </p:cViewPr>
      <p:guideLst>
        <p:guide orient="horz" pos="2160"/>
        <p:guide pos="385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4/3/1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4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tags" Target="../tags/tag64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0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2.xml"/><Relationship Id="rId4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表格 12"/>
          <p:cNvGraphicFramePr/>
          <p:nvPr>
            <p:custDataLst>
              <p:tags r:id="rId2"/>
            </p:custDataLst>
          </p:nvPr>
        </p:nvGraphicFramePr>
        <p:xfrm>
          <a:off x="40640" y="96520"/>
          <a:ext cx="12119610" cy="66211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598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598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60833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zh-CN" altLang="en-US" sz="3200" dirty="0"/>
                        <a:t>Left</a:t>
                      </a:r>
                      <a:r>
                        <a:rPr lang="en-US" altLang="zh-CN" sz="3200" dirty="0"/>
                        <a:t> </a:t>
                      </a:r>
                      <a:r>
                        <a:rPr lang="zh-CN" altLang="en-US" sz="3200" dirty="0"/>
                        <a:t>electrode</a:t>
                      </a:r>
                      <a:r>
                        <a:rPr lang="en-US" altLang="zh-CN" sz="3200" dirty="0"/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3200"/>
                        <a:t>Right electrod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4485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m</a:t>
                      </a:r>
                      <a:r>
                        <a:rPr lang="en-US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: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occipital lobe-occipit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KK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temporal-occipital junction-occipit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6487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n</a:t>
                      </a:r>
                      <a:r>
                        <a:rPr lang="en-US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: 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occipital lobe-occipit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M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temporal-occipital junction-occipit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9309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h:</a:t>
                      </a:r>
                      <a:r>
                        <a:rPr lang="en-US" altLang="zh-CN" sz="2000" dirty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 dirty="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temporal-occipital junction-occipit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  <a:endParaRPr lang="en-US" sz="2000" dirty="0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N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superior temporal gyrus-atrial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8549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i: 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temporal-occipital junction-occipit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I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middle temporal gyrus posterior-tempor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6423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k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iddle temporal gyrus-atrial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H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iddle temporal gyrus-tempor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86487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e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iddle temporal gyrus-tempor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B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iddle temporal gyrus-tempor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9372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d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iddle temporal gyrus-temporal horn 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zh-CN" altLang="en-US" sz="200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0167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2000" b="1">
                          <a:latin typeface="Times New Roman" panose="02020603050405020304" charset="0"/>
                          <a:cs typeface="Times New Roman" panose="02020603050405020304" charset="0"/>
                        </a:rPr>
                        <a:t>b:</a:t>
                      </a:r>
                      <a:r>
                        <a:rPr lang="en-US" altLang="zh-CN"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</a:rPr>
                        <a:t>middle temporal gyrus-temporal horn </a:t>
                      </a:r>
                      <a:r>
                        <a:rPr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node</a:t>
                      </a:r>
                      <a:r>
                        <a:rPr lang="en-US" sz="20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endParaRPr lang="zh-CN" altLang="en-US" sz="200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  <p:custDataLst>
      <p:tags r:id="rId1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609725" y="-635"/>
            <a:ext cx="9147810" cy="6858000"/>
            <a:chOff x="2503" y="-1"/>
            <a:chExt cx="14406" cy="108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03" y="-1"/>
              <a:ext cx="14407" cy="10801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8500" y="6198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d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7348" y="6974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b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9044" y="6566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e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0044" y="6414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k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1780" y="6270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i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2260" y="6851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h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4052" y="5241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n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3060" y="5865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m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255" y="750"/>
              <a:ext cx="1179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Left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687195" y="0"/>
            <a:ext cx="8816975" cy="6858000"/>
            <a:chOff x="2680" y="0"/>
            <a:chExt cx="13885" cy="108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80" y="0"/>
              <a:ext cx="13885" cy="10800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8050" y="4148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N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5033" y="5868"/>
              <a:ext cx="991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KK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6640" y="6128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M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7650" y="6677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I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9350" y="5868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H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940" y="6588"/>
              <a:ext cx="544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/>
                <a:t>B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255" y="750"/>
              <a:ext cx="1893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Right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>
            <a:grpSpLocks noChangeAspect="1"/>
          </p:cNvGrpSpPr>
          <p:nvPr/>
        </p:nvGrpSpPr>
        <p:grpSpPr>
          <a:xfrm>
            <a:off x="1877060" y="0"/>
            <a:ext cx="8436610" cy="6858000"/>
            <a:chOff x="2810" y="0"/>
            <a:chExt cx="13286" cy="10800"/>
          </a:xfrm>
        </p:grpSpPr>
        <p:grpSp>
          <p:nvGrpSpPr>
            <p:cNvPr id="20" name="组合 19"/>
            <p:cNvGrpSpPr/>
            <p:nvPr/>
          </p:nvGrpSpPr>
          <p:grpSpPr>
            <a:xfrm>
              <a:off x="2810" y="0"/>
              <a:ext cx="13286" cy="10800"/>
              <a:chOff x="2956" y="0"/>
              <a:chExt cx="13286" cy="10800"/>
            </a:xfrm>
          </p:grpSpPr>
          <p:pic>
            <p:nvPicPr>
              <p:cNvPr id="4" name="图片 3" descr="15157383044413691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956" y="0"/>
                <a:ext cx="13287" cy="10800"/>
              </a:xfrm>
              <a:prstGeom prst="rect">
                <a:avLst/>
              </a:prstGeom>
            </p:spPr>
          </p:pic>
          <p:sp>
            <p:nvSpPr>
              <p:cNvPr id="5" name="文本框 4"/>
              <p:cNvSpPr txBox="1"/>
              <p:nvPr/>
            </p:nvSpPr>
            <p:spPr>
              <a:xfrm>
                <a:off x="15015" y="3321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15428" y="4851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d</a:t>
                </a: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15559" y="583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e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5559" y="6825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</a:t>
                </a: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14786" y="821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12573" y="9310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3960" y="8766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1288" y="10123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4020" y="2963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3629" y="3870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3629" y="5125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3476" y="6825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6664" y="7374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7220" y="8173"/>
                <a:ext cx="982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K</a:t>
                </a:r>
              </a:p>
            </p:txBody>
          </p:sp>
        </p:grpSp>
        <p:sp>
          <p:nvSpPr>
            <p:cNvPr id="2" name="文本框 1"/>
            <p:cNvSpPr txBox="1"/>
            <p:nvPr/>
          </p:nvSpPr>
          <p:spPr>
            <a:xfrm>
              <a:off x="14358" y="262"/>
              <a:ext cx="1179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Left</a:t>
              </a: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3199" y="262"/>
              <a:ext cx="1893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 dirty="0">
                  <a:solidFill>
                    <a:schemeClr val="bg1"/>
                  </a:solidFill>
                </a:rPr>
                <a:t>Right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/>
          <p:cNvGrpSpPr>
            <a:grpSpLocks noChangeAspect="1"/>
          </p:cNvGrpSpPr>
          <p:nvPr/>
        </p:nvGrpSpPr>
        <p:grpSpPr>
          <a:xfrm>
            <a:off x="1775460" y="0"/>
            <a:ext cx="8641715" cy="6857365"/>
            <a:chOff x="2796" y="0"/>
            <a:chExt cx="13609" cy="1079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96" y="0"/>
              <a:ext cx="13609" cy="1079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9217" y="5571"/>
              <a:ext cx="70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1337" y="5535"/>
              <a:ext cx="70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3323" y="5691"/>
              <a:ext cx="706" cy="53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4811" y="4841"/>
              <a:ext cx="70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1207" y="6225"/>
              <a:ext cx="70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k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5699" y="4147"/>
              <a:ext cx="70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2293" y="4147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KK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0137" y="2177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8297" y="4227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7217" y="665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8043" y="742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0351" y="623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3373" y="742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2343" y="5227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200" b="1">
                  <a:solidFill>
                    <a:schemeClr val="bg1"/>
                  </a:solidFill>
                </a:rPr>
                <a:t>M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>
            <a:grpSpLocks noChangeAspect="1"/>
          </p:cNvGrpSpPr>
          <p:nvPr/>
        </p:nvGrpSpPr>
        <p:grpSpPr>
          <a:xfrm>
            <a:off x="2158365" y="0"/>
            <a:ext cx="8358505" cy="6858000"/>
            <a:chOff x="3269" y="0"/>
            <a:chExt cx="13163" cy="10800"/>
          </a:xfrm>
        </p:grpSpPr>
        <p:grpSp>
          <p:nvGrpSpPr>
            <p:cNvPr id="7" name="组合 6"/>
            <p:cNvGrpSpPr/>
            <p:nvPr/>
          </p:nvGrpSpPr>
          <p:grpSpPr>
            <a:xfrm>
              <a:off x="3269" y="0"/>
              <a:ext cx="12648" cy="10800"/>
              <a:chOff x="3269" y="0"/>
              <a:chExt cx="12648" cy="1080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269" y="0"/>
                <a:ext cx="12648" cy="10800"/>
              </a:xfrm>
              <a:prstGeom prst="rect">
                <a:avLst/>
              </a:prstGeom>
            </p:spPr>
          </p:pic>
          <p:sp>
            <p:nvSpPr>
              <p:cNvPr id="5" name="文本框 4"/>
              <p:cNvSpPr txBox="1"/>
              <p:nvPr/>
            </p:nvSpPr>
            <p:spPr>
              <a:xfrm>
                <a:off x="14648" y="182"/>
                <a:ext cx="1179" cy="74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Left</a:t>
                </a: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3489" y="182"/>
                <a:ext cx="1893" cy="74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Right</a:t>
                </a:r>
              </a:p>
            </p:txBody>
          </p:sp>
        </p:grpSp>
        <p:sp>
          <p:nvSpPr>
            <p:cNvPr id="12" name="文本框 11"/>
            <p:cNvSpPr txBox="1"/>
            <p:nvPr/>
          </p:nvSpPr>
          <p:spPr>
            <a:xfrm>
              <a:off x="3664" y="254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538" y="4936"/>
              <a:ext cx="971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KK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3269" y="4962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712" y="5534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712" y="6070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712" y="7159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2362" y="4789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3634" y="5093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5580" y="5937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3328" y="6071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5606" y="6442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k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5001" y="6644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5001" y="7515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4180" y="7681"/>
              <a:ext cx="826" cy="6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</a:rPr>
                <a:t>h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4850" y="0"/>
            <a:ext cx="8242300" cy="688975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273040" y="4391660"/>
            <a:ext cx="52578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2400" b="1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096000" y="2916555"/>
            <a:ext cx="593090" cy="3486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2400" b="1">
                <a:solidFill>
                  <a:schemeClr val="bg1"/>
                </a:solidFill>
              </a:rPr>
              <a:t>d</a:t>
            </a:r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D6A8CD81-0270-4C7C-9284-3586014C719D}"/>
              </a:ext>
            </a:extLst>
          </p:cNvPr>
          <p:cNvGrpSpPr/>
          <p:nvPr/>
        </p:nvGrpSpPr>
        <p:grpSpPr>
          <a:xfrm>
            <a:off x="1562100" y="-1"/>
            <a:ext cx="9067800" cy="6858001"/>
            <a:chOff x="1609725" y="-34925"/>
            <a:chExt cx="8972550" cy="6927850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78A952A2-01F8-4C50-84D4-7032251B881A}"/>
                </a:ext>
              </a:extLst>
            </p:cNvPr>
            <p:cNvGrpSpPr/>
            <p:nvPr/>
          </p:nvGrpSpPr>
          <p:grpSpPr>
            <a:xfrm>
              <a:off x="1609725" y="-34925"/>
              <a:ext cx="8972550" cy="6927850"/>
              <a:chOff x="1609725" y="-34925"/>
              <a:chExt cx="8972550" cy="692785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09725" y="-34925"/>
                <a:ext cx="8972550" cy="6927850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114BC29-838C-417B-B20E-E304A3FCDAE9}"/>
                  </a:ext>
                </a:extLst>
              </p:cNvPr>
              <p:cNvSpPr txBox="1"/>
              <p:nvPr/>
            </p:nvSpPr>
            <p:spPr>
              <a:xfrm>
                <a:off x="9210040" y="166370"/>
                <a:ext cx="748665" cy="4730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Left</a:t>
                </a: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6E2BFCC1-536C-4F3B-B087-9C80EE04EEEB}"/>
                  </a:ext>
                </a:extLst>
              </p:cNvPr>
              <p:cNvSpPr txBox="1"/>
              <p:nvPr/>
            </p:nvSpPr>
            <p:spPr>
              <a:xfrm>
                <a:off x="2124075" y="166370"/>
                <a:ext cx="1202055" cy="4730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 dirty="0">
                    <a:solidFill>
                      <a:schemeClr val="bg1"/>
                    </a:solidFill>
                  </a:rPr>
                  <a:t>Right</a:t>
                </a:r>
              </a:p>
            </p:txBody>
          </p:sp>
        </p:grpSp>
        <p:sp>
          <p:nvSpPr>
            <p:cNvPr id="5" name="文本框 4"/>
            <p:cNvSpPr txBox="1"/>
            <p:nvPr/>
          </p:nvSpPr>
          <p:spPr>
            <a:xfrm>
              <a:off x="9668510" y="4329430"/>
              <a:ext cx="582930" cy="45148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9879965" y="2935605"/>
              <a:ext cx="448310" cy="38989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d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>
            <a:grpSpLocks noChangeAspect="1"/>
          </p:cNvGrpSpPr>
          <p:nvPr/>
        </p:nvGrpSpPr>
        <p:grpSpPr>
          <a:xfrm>
            <a:off x="1663700" y="0"/>
            <a:ext cx="8872855" cy="6858000"/>
            <a:chOff x="2842" y="0"/>
            <a:chExt cx="13973" cy="10800"/>
          </a:xfrm>
        </p:grpSpPr>
        <p:grpSp>
          <p:nvGrpSpPr>
            <p:cNvPr id="2" name="组合 1"/>
            <p:cNvGrpSpPr/>
            <p:nvPr/>
          </p:nvGrpSpPr>
          <p:grpSpPr>
            <a:xfrm>
              <a:off x="2842" y="0"/>
              <a:ext cx="13973" cy="10800"/>
              <a:chOff x="2691" y="4"/>
              <a:chExt cx="13973" cy="10800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91" y="8"/>
                <a:ext cx="13973" cy="10796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3471" y="921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4" name="文本框 3"/>
              <p:cNvSpPr txBox="1"/>
              <p:nvPr/>
            </p:nvSpPr>
            <p:spPr>
              <a:xfrm>
                <a:off x="2759" y="508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3019" y="416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3303" y="291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3763" y="185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e</a:t>
                </a: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4708" y="185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d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5473" y="4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15898" y="4323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15898" y="671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12438" y="7413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15723" y="928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3588" y="942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12933" y="9977"/>
                <a:ext cx="98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K</a:t>
                </a: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2759" y="7732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  <p:sp>
          <p:nvSpPr>
            <p:cNvPr id="5" name="文本框 4"/>
            <p:cNvSpPr txBox="1"/>
            <p:nvPr/>
          </p:nvSpPr>
          <p:spPr>
            <a:xfrm>
              <a:off x="3064" y="306"/>
              <a:ext cx="1179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Left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4922" y="310"/>
              <a:ext cx="1893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Right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>
            <a:grpSpLocks noChangeAspect="1"/>
          </p:cNvGrpSpPr>
          <p:nvPr/>
        </p:nvGrpSpPr>
        <p:grpSpPr>
          <a:xfrm>
            <a:off x="0" y="0"/>
            <a:ext cx="10381471" cy="6613946"/>
            <a:chOff x="1191" y="0"/>
            <a:chExt cx="17032" cy="10936"/>
          </a:xfrm>
        </p:grpSpPr>
        <p:grpSp>
          <p:nvGrpSpPr>
            <p:cNvPr id="2" name="组合 1"/>
            <p:cNvGrpSpPr/>
            <p:nvPr/>
          </p:nvGrpSpPr>
          <p:grpSpPr>
            <a:xfrm>
              <a:off x="1191" y="0"/>
              <a:ext cx="17032" cy="10936"/>
              <a:chOff x="1256" y="1"/>
              <a:chExt cx="17032" cy="10936"/>
            </a:xfrm>
          </p:grpSpPr>
          <p:pic>
            <p:nvPicPr>
              <p:cNvPr id="4" name="图片 3" descr="69856794825430323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56" y="1"/>
                <a:ext cx="17032" cy="10936"/>
              </a:xfrm>
              <a:prstGeom prst="rect">
                <a:avLst/>
              </a:prstGeom>
            </p:spPr>
          </p:pic>
          <p:sp>
            <p:nvSpPr>
              <p:cNvPr id="13" name="文本框 12"/>
              <p:cNvSpPr txBox="1"/>
              <p:nvPr/>
            </p:nvSpPr>
            <p:spPr>
              <a:xfrm>
                <a:off x="4788" y="993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3288" y="853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4408" y="545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1468" y="557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2948" y="421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2948" y="2897"/>
                <a:ext cx="1420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K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11128" y="17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3268" y="43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3968" y="1697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15448" y="2246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16748" y="366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</a:t>
                </a: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17292" y="502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e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7292" y="690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d</a:t>
                </a: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17292" y="8788"/>
                <a:ext cx="544" cy="54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</p:grpSp>
        <p:sp>
          <p:nvSpPr>
            <p:cNvPr id="3" name="文本框 2"/>
            <p:cNvSpPr txBox="1"/>
            <p:nvPr/>
          </p:nvSpPr>
          <p:spPr>
            <a:xfrm>
              <a:off x="16366" y="231"/>
              <a:ext cx="1404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Left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534" y="240"/>
              <a:ext cx="1893" cy="74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Right</a:t>
              </a:r>
            </a:p>
          </p:txBody>
        </p:sp>
      </p:grpSp>
      <p:grpSp>
        <p:nvGrpSpPr>
          <p:cNvPr id="53" name="组合 52"/>
          <p:cNvGrpSpPr>
            <a:grpSpLocks noChangeAspect="1"/>
          </p:cNvGrpSpPr>
          <p:nvPr/>
        </p:nvGrpSpPr>
        <p:grpSpPr>
          <a:xfrm>
            <a:off x="10381615" y="-32385"/>
            <a:ext cx="1810385" cy="3213735"/>
            <a:chOff x="15676" y="-59"/>
            <a:chExt cx="3150" cy="5589"/>
          </a:xfrm>
        </p:grpSpPr>
        <p:grpSp>
          <p:nvGrpSpPr>
            <p:cNvPr id="38" name="组合 37"/>
            <p:cNvGrpSpPr/>
            <p:nvPr/>
          </p:nvGrpSpPr>
          <p:grpSpPr>
            <a:xfrm>
              <a:off x="15676" y="0"/>
              <a:ext cx="3150" cy="5530"/>
              <a:chOff x="15676" y="0"/>
              <a:chExt cx="3150" cy="5530"/>
            </a:xfrm>
          </p:grpSpPr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4"/>
              <a:srcRect l="13948" r="26919"/>
              <a:stretch>
                <a:fillRect/>
              </a:stretch>
            </p:blipFill>
            <p:spPr>
              <a:xfrm rot="10800000">
                <a:off x="15676" y="0"/>
                <a:ext cx="3150" cy="5530"/>
              </a:xfrm>
              <a:prstGeom prst="rect">
                <a:avLst/>
              </a:prstGeom>
            </p:spPr>
          </p:pic>
          <p:cxnSp>
            <p:nvCxnSpPr>
              <p:cNvPr id="23" name="直接箭头连接符 22"/>
              <p:cNvCxnSpPr/>
              <p:nvPr/>
            </p:nvCxnSpPr>
            <p:spPr>
              <a:xfrm>
                <a:off x="17285" y="4575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4" name="直接箭头连接符 23"/>
              <p:cNvCxnSpPr/>
              <p:nvPr/>
            </p:nvCxnSpPr>
            <p:spPr>
              <a:xfrm flipH="1" flipV="1">
                <a:off x="16787" y="4197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5" name="直接箭头连接符 24"/>
              <p:cNvCxnSpPr/>
              <p:nvPr/>
            </p:nvCxnSpPr>
            <p:spPr>
              <a:xfrm>
                <a:off x="17285" y="3835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6" name="直接箭头连接符 25"/>
              <p:cNvCxnSpPr/>
              <p:nvPr/>
            </p:nvCxnSpPr>
            <p:spPr>
              <a:xfrm>
                <a:off x="17351" y="3111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7" name="直接箭头连接符 26"/>
              <p:cNvCxnSpPr/>
              <p:nvPr/>
            </p:nvCxnSpPr>
            <p:spPr>
              <a:xfrm>
                <a:off x="17399" y="1647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28" name="直接箭头连接符 27"/>
              <p:cNvCxnSpPr/>
              <p:nvPr/>
            </p:nvCxnSpPr>
            <p:spPr>
              <a:xfrm>
                <a:off x="17399" y="996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3" name="直接箭头连接符 32"/>
              <p:cNvCxnSpPr/>
              <p:nvPr/>
            </p:nvCxnSpPr>
            <p:spPr>
              <a:xfrm>
                <a:off x="17333" y="2411"/>
                <a:ext cx="455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4" name="直接箭头连接符 33"/>
              <p:cNvCxnSpPr/>
              <p:nvPr/>
            </p:nvCxnSpPr>
            <p:spPr>
              <a:xfrm flipH="1" flipV="1">
                <a:off x="16802" y="3481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5" name="直接箭头连接符 34"/>
              <p:cNvCxnSpPr/>
              <p:nvPr/>
            </p:nvCxnSpPr>
            <p:spPr>
              <a:xfrm flipH="1" flipV="1">
                <a:off x="16850" y="2765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6" name="直接箭头连接符 35"/>
              <p:cNvCxnSpPr/>
              <p:nvPr/>
            </p:nvCxnSpPr>
            <p:spPr>
              <a:xfrm flipH="1" flipV="1">
                <a:off x="16867" y="2050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7" name="直接箭头连接符 36"/>
              <p:cNvCxnSpPr/>
              <p:nvPr/>
            </p:nvCxnSpPr>
            <p:spPr>
              <a:xfrm flipH="1" flipV="1">
                <a:off x="16916" y="1335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39" name="直接箭头连接符 38"/>
              <p:cNvCxnSpPr/>
              <p:nvPr/>
            </p:nvCxnSpPr>
            <p:spPr>
              <a:xfrm flipH="1" flipV="1">
                <a:off x="16850" y="619"/>
                <a:ext cx="369" cy="2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sp>
          <p:nvSpPr>
            <p:cNvPr id="22" name="文本框 21"/>
            <p:cNvSpPr txBox="1"/>
            <p:nvPr/>
          </p:nvSpPr>
          <p:spPr>
            <a:xfrm>
              <a:off x="16753" y="-59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b="1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17575" y="4354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1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7693" y="3612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7695" y="2838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5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7696" y="2140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7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7743" y="1451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9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7696" y="731"/>
              <a:ext cx="755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11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6362" y="406"/>
              <a:ext cx="740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12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6362" y="1077"/>
              <a:ext cx="724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16543" y="1802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8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16502" y="2518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6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6468" y="3199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4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6469" y="3984"/>
              <a:ext cx="496" cy="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400">
                  <a:solidFill>
                    <a:schemeClr val="bg1"/>
                  </a:solidFill>
                </a:rPr>
                <a:t>2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>
            <a:grpSpLocks noChangeAspect="1"/>
          </p:cNvGrpSpPr>
          <p:nvPr/>
        </p:nvGrpSpPr>
        <p:grpSpPr>
          <a:xfrm>
            <a:off x="1383030" y="635"/>
            <a:ext cx="9422130" cy="6854190"/>
            <a:chOff x="2178" y="1"/>
            <a:chExt cx="14838" cy="10794"/>
          </a:xfrm>
        </p:grpSpPr>
        <p:grpSp>
          <p:nvGrpSpPr>
            <p:cNvPr id="19" name="组合 18"/>
            <p:cNvGrpSpPr/>
            <p:nvPr/>
          </p:nvGrpSpPr>
          <p:grpSpPr>
            <a:xfrm>
              <a:off x="2178" y="1"/>
              <a:ext cx="14838" cy="10794"/>
              <a:chOff x="2178" y="1"/>
              <a:chExt cx="14838" cy="10794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178" y="1"/>
                <a:ext cx="14838" cy="10794"/>
              </a:xfrm>
              <a:prstGeom prst="rect">
                <a:avLst/>
              </a:prstGeom>
            </p:spPr>
          </p:pic>
          <p:sp>
            <p:nvSpPr>
              <p:cNvPr id="10" name="文本框 9"/>
              <p:cNvSpPr txBox="1"/>
              <p:nvPr/>
            </p:nvSpPr>
            <p:spPr>
              <a:xfrm>
                <a:off x="10240" y="9860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11816" y="9633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12338" y="8348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13786" y="8348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5234" y="7096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</a:t>
                </a: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15657" y="6038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e</a:t>
                </a: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5884" y="5139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d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5413" y="3277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5375" y="494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B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4091" y="1908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H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4384" y="4218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I</a:t>
                </a: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2549" y="4266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N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3571" y="5662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3718" y="6686"/>
                <a:ext cx="1025" cy="52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400" b="1">
                    <a:solidFill>
                      <a:schemeClr val="bg1"/>
                    </a:solidFill>
                  </a:rPr>
                  <a:t>KK</a:t>
                </a:r>
              </a:p>
            </p:txBody>
          </p:sp>
        </p:grpSp>
        <p:sp>
          <p:nvSpPr>
            <p:cNvPr id="20" name="文本框 19"/>
            <p:cNvSpPr txBox="1"/>
            <p:nvPr/>
          </p:nvSpPr>
          <p:spPr>
            <a:xfrm>
              <a:off x="15382" y="220"/>
              <a:ext cx="1348" cy="7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Left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567" y="229"/>
              <a:ext cx="1817" cy="7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400" b="1">
                  <a:solidFill>
                    <a:schemeClr val="bg1"/>
                  </a:solidFill>
                </a:rPr>
                <a:t>Right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WY5M2E0ZjQyMGJiMzkyMzFhZjA4ZjUwYmJjMWRmYzk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fc7fd143-76c7-450a-b315-7a9161d01f9d}"/>
  <p:tag name="TABLE_ENDDRAG_ORIGIN_RECT" val="954*521"/>
  <p:tag name="TABLE_ENDDRAG_RECT" val="5*18*954*521"/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38</Words>
  <Application>Microsoft Office PowerPoint</Application>
  <PresentationFormat>宽屏</PresentationFormat>
  <Paragraphs>145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微软雅黑</vt:lpstr>
      <vt:lpstr>Arial</vt:lpstr>
      <vt:lpstr>Times New Roman</vt:lpstr>
      <vt:lpstr>Wingding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李 子健</cp:lastModifiedBy>
  <cp:revision>188</cp:revision>
  <dcterms:created xsi:type="dcterms:W3CDTF">2019-06-19T02:08:00Z</dcterms:created>
  <dcterms:modified xsi:type="dcterms:W3CDTF">2024-03-17T05:19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388</vt:lpwstr>
  </property>
  <property fmtid="{D5CDD505-2E9C-101B-9397-08002B2CF9AE}" pid="3" name="ICV">
    <vt:lpwstr>5C07D5BA6C9F4159939AEACCBE2C09E7_13</vt:lpwstr>
  </property>
</Properties>
</file>